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65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908F1E-C65A-410E-AFD1-94CD071822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2AF1F5-69B7-4257-9AE1-D6370804E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A33B7-44E2-4E9C-8AD1-0A29FE37A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96526-DD64-47BD-97F8-CC795981B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9460D5-36ED-4E7F-B385-67FAC9396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5787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9B71F-688A-4AD7-B087-14FCD15B0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880C3D-2C0F-4BA0-9784-C8450E3F2F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3EBE48-4464-44C2-B6C0-D7660FAC1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899A46-D065-4C10-8436-9B75B05A8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97B915-3DA6-4FF2-80BD-39C88114C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9531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E54AC1-7DED-4340-821E-8281D84BE2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6C1C75-502F-456D-8FB2-06B92B6257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FD4E3-9070-4F44-BEEB-757086ED0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EC6B6B-6EBE-496D-A0F4-A7A03316F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070B7D-64EA-43D3-97AE-35CB97FBD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04957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920EB6-04BC-4D25-B6C4-60E2DE0F6F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03019-6D04-479C-B1D8-3B976007BE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65F2FB-817F-4D55-9F74-359DAB990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44F748-65B5-44CD-A5FD-528B899A3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F36B08-96E2-4148-8460-0ED4AC51F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37137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05475-6451-46D2-AD6D-CBC965228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A8CDEF-2821-4B45-8DFE-BF286E7F1E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68FF8D-6713-4931-AB24-CDAA9C5A3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79DC5F-2753-48B2-AA3E-4B59F504F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7F055A-E52B-4EB3-B359-DE245F9D0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2456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D56C45-B763-442F-AC18-30ACB0B56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3614FE-6F51-4E11-9F01-92E14BBB68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54AE00-D305-4A87-86B3-FADF35AE9C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DE48EB-8742-46FB-A4F4-F63610CE5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0DA339-8DB4-49B0-8180-C160E677B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E62417-87EE-4BE0-AABD-87A9F6D9F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593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D0405-D3B0-4604-8CD2-8FE12AEBA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F6049B-1483-48B4-8F56-9B7A9A480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4E7A2D-E1EC-49F7-9B42-A121568149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4BFD46-BCED-4EF8-80F2-10AB9DAF90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A43666-0ABC-4A60-ADEF-50259210C4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B2B6C9-93F8-4F19-A26A-270263669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B3BD34-E3BD-4C59-86CA-C123293D0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3EC12B-62A3-4A21-B40E-01B60FC4E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3557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461AD-DCA1-48FD-937B-BAD2B5E64D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A26B73-52C6-48FD-92F9-722FA65E2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1DB9B9-4E66-4CDE-ADB5-EE73AB55D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BAC72C-662D-4117-B5BF-769C514C2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0010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76C3B4-C041-4DD4-A80B-8C07114DF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4E33BD-3C74-4515-97F3-686499730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37A7B1-A6FC-46C4-9070-2198259C1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250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0BAE1-0763-480B-ADC2-76CCD1D33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83303-F84A-47D7-9E90-F9C6E6CE27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CEB543-D5A6-4955-AAD0-298A4BEADC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8D9987-CD06-4D6B-95D5-F8A10E7F6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B3C2BD-3330-432D-B7BC-E767665BA4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9B96BD-1C04-4DC4-83B4-967A89643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50887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9F4466-CC6F-4CC6-ADA9-3F7A55B98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53CC6B-A055-4A44-8ABD-9805B5BF46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F6E25B-063D-4411-9CFC-D187ABD324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F52945-E90F-41E2-BAB6-9956D2763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807557-0C6B-4AF9-9A09-4477095C0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3010F3-3984-4BEA-9394-C3C3ADEB5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529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89B41B-8F49-4FBD-83EA-48AF19630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009B53-8908-4690-8763-496F067D22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F9897A-0150-4CBE-A716-670EF2739D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A1910-2B3D-430A-983C-5CF3D1563581}" type="datetimeFigureOut">
              <a:rPr lang="en-AU" smtClean="0"/>
              <a:t>9/06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EF8B2F-7357-4CDF-B832-3D0E8928DA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1FAB3-57A6-43A9-B2FB-75C3D88E81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59B74C-AF29-4C9B-B6E7-5B83EC92834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80160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white, sitting, building, front&#10;&#10;Description automatically generated">
            <a:extLst>
              <a:ext uri="{FF2B5EF4-FFF2-40B4-BE49-F238E27FC236}">
                <a16:creationId xmlns:a16="http://schemas.microsoft.com/office/drawing/2014/main" id="{A55B808A-419C-4BC5-B772-CFD75E5E4EE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46" b="3990"/>
          <a:stretch/>
        </p:blipFill>
        <p:spPr>
          <a:xfrm>
            <a:off x="2369430" y="1128366"/>
            <a:ext cx="8146170" cy="5675455"/>
          </a:xfrm>
          <a:prstGeom prst="rect">
            <a:avLst/>
          </a:prstGeom>
        </p:spPr>
      </p:pic>
      <p:sp>
        <p:nvSpPr>
          <p:cNvPr id="6" name="Rectangle 2">
            <a:extLst>
              <a:ext uri="{FF2B5EF4-FFF2-40B4-BE49-F238E27FC236}">
                <a16:creationId xmlns:a16="http://schemas.microsoft.com/office/drawing/2014/main" id="{FDF494FD-0961-4684-8508-6191A873200C}"/>
              </a:ext>
            </a:extLst>
          </p:cNvPr>
          <p:cNvSpPr txBox="1">
            <a:spLocks noChangeArrowheads="1"/>
          </p:cNvSpPr>
          <p:nvPr/>
        </p:nvSpPr>
        <p:spPr>
          <a:xfrm>
            <a:off x="3942128" y="-76200"/>
            <a:ext cx="4371975" cy="534248"/>
          </a:xfrm>
          <a:prstGeom prst="rect">
            <a:avLst/>
          </a:prstGeom>
        </p:spPr>
        <p:txBody>
          <a:bodyPr vert="horz" lIns="68580" tIns="34290" rIns="68580" bIns="34290" rtlCol="0" anchor="ctr">
            <a:normAutofit fontScale="925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AU" altLang="en-US" sz="3300" dirty="0"/>
              <a:t>Gel 274</a:t>
            </a:r>
          </a:p>
        </p:txBody>
      </p:sp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B711006B-DBB8-4C2F-810C-081A33CAB62E}"/>
              </a:ext>
            </a:extLst>
          </p:cNvPr>
          <p:cNvGraphicFramePr>
            <a:graphicFrameLocks noGrp="1"/>
          </p:cNvGraphicFramePr>
          <p:nvPr/>
        </p:nvGraphicFramePr>
        <p:xfrm>
          <a:off x="2409167" y="560101"/>
          <a:ext cx="7938770" cy="543270"/>
        </p:xfrm>
        <a:graphic>
          <a:graphicData uri="http://schemas.openxmlformats.org/drawingml/2006/table">
            <a:tbl>
              <a:tblPr/>
              <a:tblGrid>
                <a:gridCol w="410233">
                  <a:extLst>
                    <a:ext uri="{9D8B030D-6E8A-4147-A177-3AD203B41FA5}">
                      <a16:colId xmlns:a16="http://schemas.microsoft.com/office/drawing/2014/main" val="1475508775"/>
                    </a:ext>
                  </a:extLst>
                </a:gridCol>
                <a:gridCol w="518137">
                  <a:extLst>
                    <a:ext uri="{9D8B030D-6E8A-4147-A177-3AD203B41FA5}">
                      <a16:colId xmlns:a16="http://schemas.microsoft.com/office/drawing/2014/main" val="3593135976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711797634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2289729295"/>
                    </a:ext>
                  </a:extLst>
                </a:gridCol>
                <a:gridCol w="548663">
                  <a:extLst>
                    <a:ext uri="{9D8B030D-6E8A-4147-A177-3AD203B41FA5}">
                      <a16:colId xmlns:a16="http://schemas.microsoft.com/office/drawing/2014/main" val="616154749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43627811"/>
                    </a:ext>
                  </a:extLst>
                </a:gridCol>
                <a:gridCol w="365737">
                  <a:extLst>
                    <a:ext uri="{9D8B030D-6E8A-4147-A177-3AD203B41FA5}">
                      <a16:colId xmlns:a16="http://schemas.microsoft.com/office/drawing/2014/main" val="3895080439"/>
                    </a:ext>
                  </a:extLst>
                </a:gridCol>
                <a:gridCol w="548663">
                  <a:extLst>
                    <a:ext uri="{9D8B030D-6E8A-4147-A177-3AD203B41FA5}">
                      <a16:colId xmlns:a16="http://schemas.microsoft.com/office/drawing/2014/main" val="2482174525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1245151677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3542574114"/>
                    </a:ext>
                  </a:extLst>
                </a:gridCol>
                <a:gridCol w="362562">
                  <a:extLst>
                    <a:ext uri="{9D8B030D-6E8A-4147-A177-3AD203B41FA5}">
                      <a16:colId xmlns:a16="http://schemas.microsoft.com/office/drawing/2014/main" val="3803743193"/>
                    </a:ext>
                  </a:extLst>
                </a:gridCol>
                <a:gridCol w="536575">
                  <a:extLst>
                    <a:ext uri="{9D8B030D-6E8A-4147-A177-3AD203B41FA5}">
                      <a16:colId xmlns:a16="http://schemas.microsoft.com/office/drawing/2014/main" val="3573996298"/>
                    </a:ext>
                  </a:extLst>
                </a:gridCol>
                <a:gridCol w="467995">
                  <a:extLst>
                    <a:ext uri="{9D8B030D-6E8A-4147-A177-3AD203B41FA5}">
                      <a16:colId xmlns:a16="http://schemas.microsoft.com/office/drawing/2014/main" val="2957593721"/>
                    </a:ext>
                  </a:extLst>
                </a:gridCol>
                <a:gridCol w="522605">
                  <a:extLst>
                    <a:ext uri="{9D8B030D-6E8A-4147-A177-3AD203B41FA5}">
                      <a16:colId xmlns:a16="http://schemas.microsoft.com/office/drawing/2014/main" val="1095902721"/>
                    </a:ext>
                  </a:extLst>
                </a:gridCol>
                <a:gridCol w="520065">
                  <a:extLst>
                    <a:ext uri="{9D8B030D-6E8A-4147-A177-3AD203B41FA5}">
                      <a16:colId xmlns:a16="http://schemas.microsoft.com/office/drawing/2014/main" val="3217800157"/>
                    </a:ext>
                  </a:extLst>
                </a:gridCol>
                <a:gridCol w="546735">
                  <a:extLst>
                    <a:ext uri="{9D8B030D-6E8A-4147-A177-3AD203B41FA5}">
                      <a16:colId xmlns:a16="http://schemas.microsoft.com/office/drawing/2014/main" val="382355663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Lane</a:t>
                      </a:r>
                      <a:endParaRPr lang="en-AU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</a:t>
                      </a:r>
                      <a:endParaRPr lang="en-AU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2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L- 3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L- 4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 5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 6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 7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8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9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0 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 11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2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3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4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AU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-15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8900671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1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mp</a:t>
                      </a:r>
                      <a:endParaRPr lang="en-AU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1" u="none" strike="noStrike" dirty="0">
                          <a:effectLst/>
                        </a:rPr>
                        <a:t>MWM</a:t>
                      </a:r>
                      <a:endParaRPr lang="en-AU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100" b="1" u="none" strike="noStrike" dirty="0">
                          <a:effectLst/>
                        </a:rPr>
                        <a:t>Pool -1</a:t>
                      </a:r>
                      <a:endParaRPr lang="en-AU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Pool -1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Pool -1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Blank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10 M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10 N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Blank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24 M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24 N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24 O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 P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nk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40 M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100" b="1" u="none" strike="noStrike" dirty="0">
                          <a:effectLst/>
                        </a:rPr>
                        <a:t>40 N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9732194"/>
                  </a:ext>
                </a:extLst>
              </a:tr>
              <a:tr h="15875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sVol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1100" u="none" strike="noStrike" dirty="0">
                          <a:effectLst/>
                        </a:rPr>
                        <a:t>Gel-274</a:t>
                      </a:r>
                      <a:endParaRPr lang="en-AU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5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0</a:t>
                      </a:r>
                      <a:endParaRPr lang="en-AU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330" marR="7330" marT="733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240250"/>
                  </a:ext>
                </a:extLst>
              </a:tr>
            </a:tbl>
          </a:graphicData>
        </a:graphic>
      </p:graphicFrame>
      <p:sp>
        <p:nvSpPr>
          <p:cNvPr id="38" name="Rectangle 2">
            <a:extLst>
              <a:ext uri="{FF2B5EF4-FFF2-40B4-BE49-F238E27FC236}">
                <a16:creationId xmlns:a16="http://schemas.microsoft.com/office/drawing/2014/main" id="{75906648-B057-4F74-BC33-4796D04239A1}"/>
              </a:ext>
            </a:extLst>
          </p:cNvPr>
          <p:cNvSpPr txBox="1">
            <a:spLocks noChangeArrowheads="1"/>
          </p:cNvSpPr>
          <p:nvPr/>
        </p:nvSpPr>
        <p:spPr>
          <a:xfrm>
            <a:off x="3942128" y="304800"/>
            <a:ext cx="4371975" cy="234874"/>
          </a:xfrm>
          <a:prstGeom prst="rect">
            <a:avLst/>
          </a:prstGeom>
        </p:spPr>
        <p:txBody>
          <a:bodyPr vert="horz" lIns="68580" tIns="34290" rIns="68580" bIns="34290" rtlCol="0" anchor="ctr">
            <a:normAutofit fontScale="925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en-US" sz="1275" dirty="0"/>
              <a:t>Date: 19 January 2020</a:t>
            </a:r>
            <a:endParaRPr lang="en-AU" altLang="en-US" sz="1275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9085943-6251-4D94-9299-81FA4891C1B8}"/>
              </a:ext>
            </a:extLst>
          </p:cNvPr>
          <p:cNvGrpSpPr/>
          <p:nvPr/>
        </p:nvGrpSpPr>
        <p:grpSpPr>
          <a:xfrm>
            <a:off x="1866928" y="1160308"/>
            <a:ext cx="1104872" cy="5545292"/>
            <a:chOff x="111256" y="781050"/>
            <a:chExt cx="3125458" cy="7272543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16AB2B4-E2F0-48D2-AB81-4935B5B430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2749"/>
            <a:stretch/>
          </p:blipFill>
          <p:spPr>
            <a:xfrm>
              <a:off x="111256" y="781050"/>
              <a:ext cx="1672574" cy="5942674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110DAC5-C010-4A19-BDF5-4F3296D241D5}"/>
                </a:ext>
              </a:extLst>
            </p:cNvPr>
            <p:cNvGrpSpPr/>
            <p:nvPr/>
          </p:nvGrpSpPr>
          <p:grpSpPr>
            <a:xfrm>
              <a:off x="1397493" y="1497504"/>
              <a:ext cx="1839221" cy="6556089"/>
              <a:chOff x="1397493" y="1497504"/>
              <a:chExt cx="1839221" cy="6556089"/>
            </a:xfrm>
          </p:grpSpPr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F6E29FD2-30B4-4F66-9DB0-CABDC106F42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53851" y="1497504"/>
                <a:ext cx="1482862" cy="196388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C4B78752-593B-450B-A1FB-A3103BBC4B7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08480" y="1732321"/>
                <a:ext cx="1498065" cy="187567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BEFF9DD3-F60C-41F8-A7F0-B278B363CF8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08480" y="2123052"/>
                <a:ext cx="1528234" cy="68015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27A3EAC9-C520-488F-BF37-61267F62EA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08480" y="2456528"/>
                <a:ext cx="1528234" cy="80802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13521293-3BD3-4BE8-9EEF-51D5CA5FC0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22386" y="3080106"/>
                <a:ext cx="1584159" cy="9099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15197900-3A33-4AE7-8980-88E496A335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28377" y="3436943"/>
                <a:ext cx="1508336" cy="446199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7249AB8E-0A5E-4149-88E5-D6E6717F7D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0031" y="4115998"/>
                <a:ext cx="1686683" cy="853657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329CA008-999D-47E0-B5BD-D169168658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33973" y="4505178"/>
                <a:ext cx="1672572" cy="967930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2DBEAF47-C67F-4542-8EEA-9934B7ADED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3804" y="4919032"/>
                <a:ext cx="1646957" cy="1402781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>
                <a:extLst>
                  <a:ext uri="{FF2B5EF4-FFF2-40B4-BE49-F238E27FC236}">
                    <a16:creationId xmlns:a16="http://schemas.microsoft.com/office/drawing/2014/main" id="{4695BE6C-969A-4E11-B64D-FD2301458B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78189" y="5526010"/>
                <a:ext cx="1672572" cy="1586895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1D092FE7-FDA5-4AAA-A6F1-8F76A02711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7493" y="6147024"/>
                <a:ext cx="1422145" cy="1501416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01FFF406-4DB2-44CA-A71A-E9C2DD6A5F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09851" y="6509604"/>
                <a:ext cx="1490482" cy="1543989"/>
              </a:xfrm>
              <a:prstGeom prst="straightConnector1">
                <a:avLst/>
              </a:prstGeom>
              <a:ln w="28575"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516671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0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mudur Rahman</dc:creator>
  <cp:lastModifiedBy>Bronwyn Barkla</cp:lastModifiedBy>
  <cp:revision>1</cp:revision>
  <dcterms:created xsi:type="dcterms:W3CDTF">2021-06-08T13:51:59Z</dcterms:created>
  <dcterms:modified xsi:type="dcterms:W3CDTF">2021-06-08T22:46:01Z</dcterms:modified>
</cp:coreProperties>
</file>